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E65D36-53E3-49B1-8780-E2B4CFFFA6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EF2EF8-241F-4AAE-9FD5-9CF447025A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D0C1B3-C62B-49AA-823D-A6B10008FA7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48203A-96DF-4435-BDD3-919C37FBC8F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1E0D4B-F406-449D-8EBE-E3CDD7A24B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B73624-C99F-4063-B5C3-CABD444EEE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0BD43A-EDD3-4D3D-B762-3914EB3D00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FD2F4D-9EF9-46C4-9374-1E1F209726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8D5D69-B623-489C-9311-226FE0D169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E0C988-E31A-45A4-B3F2-693150256C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E96CC8-F1A3-47C0-9CA1-7F94354433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329A11-3702-4D45-B330-1101A5B6D9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23C5B5-4676-4103-A725-4ED2FC379431}" type="slidenum"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Sly&amp;Fly%20+%20Xmr-ref" descr=""/>
          <p:cNvPicPr/>
          <p:nvPr/>
        </p:nvPicPr>
        <p:blipFill>
          <a:blip r:embed="rId1"/>
          <a:stretch/>
        </p:blipFill>
        <p:spPr>
          <a:xfrm>
            <a:off x="266760" y="0"/>
            <a:ext cx="8780400" cy="625644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754200" y="5222880"/>
            <a:ext cx="102960" cy="10332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852480" y="5146560"/>
            <a:ext cx="173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Huge Repeat contig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754200" y="5464080"/>
            <a:ext cx="102960" cy="10332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852480" y="5388120"/>
            <a:ext cx="2565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Rearranged Huge Repeat contig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754200" y="5705640"/>
            <a:ext cx="102960" cy="10476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7720" bIns="277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754200" y="5946840"/>
            <a:ext cx="102960" cy="102960"/>
          </a:xfrm>
          <a:prstGeom prst="ellipse">
            <a:avLst/>
          </a:prstGeom>
          <a:solidFill>
            <a:srgbClr val="33996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754200" y="6189840"/>
            <a:ext cx="102960" cy="10296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852480" y="5626080"/>
            <a:ext cx="2565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Ssty1+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/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Asty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– rich contig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852480" y="5867280"/>
            <a:ext cx="2565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Sly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/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Asty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– rich contig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852480" y="6107040"/>
            <a:ext cx="2565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Unclassified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8574120" y="4419720"/>
            <a:ext cx="103320" cy="10296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7804080" y="4614840"/>
            <a:ext cx="103320" cy="10476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7720" bIns="277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7804080" y="4808520"/>
            <a:ext cx="103320" cy="10476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7720" bIns="277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7804080" y="5783400"/>
            <a:ext cx="103320" cy="10296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7804080" y="5392800"/>
            <a:ext cx="103320" cy="10476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7720" bIns="277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7804080" y="5199120"/>
            <a:ext cx="103320" cy="10476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7720" bIns="277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7804080" y="5978520"/>
            <a:ext cx="103320" cy="10332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7804080" y="5003640"/>
            <a:ext cx="103320" cy="10476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7720" bIns="277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7804080" y="5587920"/>
            <a:ext cx="103320" cy="10476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7720" bIns="277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7897680" y="2681280"/>
            <a:ext cx="103320" cy="10332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7896240" y="525600"/>
            <a:ext cx="103320" cy="10296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7897680" y="2292480"/>
            <a:ext cx="103320" cy="10296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7897680" y="1492200"/>
            <a:ext cx="103320" cy="10332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7896240" y="1671480"/>
            <a:ext cx="103320" cy="10332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7896240" y="324000"/>
            <a:ext cx="103320" cy="10296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7897680" y="920880"/>
            <a:ext cx="103320" cy="10476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7720" bIns="277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7896240" y="2089080"/>
            <a:ext cx="103320" cy="10476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7720" bIns="277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7896240" y="1874880"/>
            <a:ext cx="103320" cy="10332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7897680" y="2865600"/>
            <a:ext cx="103320" cy="10296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8731080" y="1298520"/>
            <a:ext cx="103320" cy="10476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7720" bIns="277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7897680" y="2468520"/>
            <a:ext cx="103320" cy="10476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7720" bIns="277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7896240" y="723960"/>
            <a:ext cx="103320" cy="10296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7896240" y="1106640"/>
            <a:ext cx="103320" cy="10296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8315280" y="3444840"/>
            <a:ext cx="103320" cy="10332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7896240" y="3255840"/>
            <a:ext cx="103320" cy="10332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7897680" y="3063960"/>
            <a:ext cx="103320" cy="102960"/>
          </a:xfrm>
          <a:prstGeom prst="ellipse">
            <a:avLst/>
          </a:prstGeom>
          <a:solidFill>
            <a:srgbClr val="33996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8315280" y="3652920"/>
            <a:ext cx="103320" cy="102960"/>
          </a:xfrm>
          <a:prstGeom prst="ellipse">
            <a:avLst/>
          </a:prstGeom>
          <a:solidFill>
            <a:srgbClr val="33996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8315280" y="3843360"/>
            <a:ext cx="103320" cy="103320"/>
          </a:xfrm>
          <a:prstGeom prst="ellipse">
            <a:avLst/>
          </a:prstGeom>
          <a:solidFill>
            <a:srgbClr val="33996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8315280" y="4033800"/>
            <a:ext cx="103320" cy="103320"/>
          </a:xfrm>
          <a:prstGeom prst="ellipse">
            <a:avLst/>
          </a:prstGeom>
          <a:solidFill>
            <a:srgbClr val="33996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7905600" y="4233960"/>
            <a:ext cx="103320" cy="10296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6146640" y="6321600"/>
            <a:ext cx="46836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arrow" w="sm"/>
            <a:tailEnd len="sm" type="arrow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4818240" y="6523200"/>
            <a:ext cx="180648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arrow" w="sm"/>
            <a:tailEnd len="sm" type="arrow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398520" y="6726240"/>
            <a:ext cx="6211800" cy="7920"/>
          </a:xfrm>
          <a:prstGeom prst="line">
            <a:avLst/>
          </a:prstGeom>
          <a:ln w="19080">
            <a:solidFill>
              <a:srgbClr val="000000"/>
            </a:solidFill>
            <a:miter/>
            <a:headEnd len="sm" type="arrow" w="sm"/>
            <a:tailEnd len="sm" type="arrow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5751360" y="6243480"/>
            <a:ext cx="619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33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4457880" y="6442200"/>
            <a:ext cx="618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87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57240" y="6648480"/>
            <a:ext cx="619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6.07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2-06T15:01:20Z</dcterms:created>
  <dc:creator>pjie2b</dc:creator>
  <dc:description/>
  <dc:language>en-US</dc:language>
  <cp:lastModifiedBy>pjie2b</cp:lastModifiedBy>
  <dcterms:modified xsi:type="dcterms:W3CDTF">2007-09-20T14:47:30Z</dcterms:modified>
  <cp:revision>1</cp:revision>
  <dc:subject/>
  <dc:title>PowerPoint Presentation</dc:title>
</cp:coreProperties>
</file>